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0442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414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0860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7020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132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8258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2364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837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963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6685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3059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2539B4-9AED-4070-8623-62FB25DC8B3C}" type="datetimeFigureOut">
              <a:rPr lang="en-GB" smtClean="0"/>
              <a:t>0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28B75A-B53F-4380-80DA-C2CDAAE72E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4385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hand holding a x-ray&#10;&#10;Description automatically generated">
            <a:extLst>
              <a:ext uri="{FF2B5EF4-FFF2-40B4-BE49-F238E27FC236}">
                <a16:creationId xmlns:a16="http://schemas.microsoft.com/office/drawing/2014/main" xmlns="" id="{B89A2824-F16B-0505-C539-9E15BB1EB0A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9233" y="1297112"/>
            <a:ext cx="9281054" cy="54734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E3E6F44-8443-D010-211E-D2242DD8F875}"/>
              </a:ext>
            </a:extLst>
          </p:cNvPr>
          <p:cNvSpPr txBox="1"/>
          <p:nvPr/>
        </p:nvSpPr>
        <p:spPr>
          <a:xfrm>
            <a:off x="-1" y="86673"/>
            <a:ext cx="3012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1B_Source Dat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EDEF8D2-2ECE-5030-79A9-FFB5CFB21B3A}"/>
              </a:ext>
            </a:extLst>
          </p:cNvPr>
          <p:cNvSpPr txBox="1"/>
          <p:nvPr/>
        </p:nvSpPr>
        <p:spPr>
          <a:xfrm rot="16200000">
            <a:off x="2549968" y="851802"/>
            <a:ext cx="1899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pty vecto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0861F796-522D-26C2-8BA2-71939A6280AB}"/>
              </a:ext>
            </a:extLst>
          </p:cNvPr>
          <p:cNvSpPr txBox="1"/>
          <p:nvPr/>
        </p:nvSpPr>
        <p:spPr>
          <a:xfrm rot="16200000">
            <a:off x="2920085" y="862684"/>
            <a:ext cx="1899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ol3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C55258E6-5948-CE25-8DCD-B0B9894162C0}"/>
              </a:ext>
            </a:extLst>
          </p:cNvPr>
          <p:cNvSpPr txBox="1"/>
          <p:nvPr/>
        </p:nvSpPr>
        <p:spPr>
          <a:xfrm rot="16200000">
            <a:off x="3301085" y="851794"/>
            <a:ext cx="1899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ol30-R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4689CA1-1343-29F9-738B-23B3355E99BA}"/>
              </a:ext>
            </a:extLst>
          </p:cNvPr>
          <p:cNvSpPr txBox="1"/>
          <p:nvPr/>
        </p:nvSpPr>
        <p:spPr>
          <a:xfrm rot="16200000">
            <a:off x="3552825" y="678985"/>
            <a:ext cx="2266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ol30-RR-SUM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8B803F24-DD62-A0F9-81A8-99D6DA62C543}"/>
              </a:ext>
            </a:extLst>
          </p:cNvPr>
          <p:cNvSpPr txBox="1"/>
          <p:nvPr/>
        </p:nvSpPr>
        <p:spPr>
          <a:xfrm rot="16200000">
            <a:off x="3977368" y="689871"/>
            <a:ext cx="2266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ol30-RR-UBI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0F09E752-012E-C265-6BD1-30503279E126}"/>
              </a:ext>
            </a:extLst>
          </p:cNvPr>
          <p:cNvCxnSpPr>
            <a:cxnSpLocks/>
          </p:cNvCxnSpPr>
          <p:nvPr/>
        </p:nvCxnSpPr>
        <p:spPr>
          <a:xfrm>
            <a:off x="3428999" y="2090057"/>
            <a:ext cx="30266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64853B59-B06C-E176-3639-EF1FA43FD9CE}"/>
              </a:ext>
            </a:extLst>
          </p:cNvPr>
          <p:cNvCxnSpPr>
            <a:cxnSpLocks/>
          </p:cNvCxnSpPr>
          <p:nvPr/>
        </p:nvCxnSpPr>
        <p:spPr>
          <a:xfrm>
            <a:off x="3755571" y="2079167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xmlns="" id="{88E087B9-3C3D-F13A-9BA3-9CBD41CAAD04}"/>
              </a:ext>
            </a:extLst>
          </p:cNvPr>
          <p:cNvCxnSpPr>
            <a:cxnSpLocks/>
          </p:cNvCxnSpPr>
          <p:nvPr/>
        </p:nvCxnSpPr>
        <p:spPr>
          <a:xfrm>
            <a:off x="4147456" y="2079164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xmlns="" id="{3726FF70-5D7C-2B41-C865-CAF4D36028C0}"/>
              </a:ext>
            </a:extLst>
          </p:cNvPr>
          <p:cNvCxnSpPr>
            <a:cxnSpLocks/>
          </p:cNvCxnSpPr>
          <p:nvPr/>
        </p:nvCxnSpPr>
        <p:spPr>
          <a:xfrm>
            <a:off x="4561113" y="2079163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xmlns="" id="{448AE1A3-0C19-870A-3D9F-46E7024F28DC}"/>
              </a:ext>
            </a:extLst>
          </p:cNvPr>
          <p:cNvCxnSpPr>
            <a:cxnSpLocks/>
          </p:cNvCxnSpPr>
          <p:nvPr/>
        </p:nvCxnSpPr>
        <p:spPr>
          <a:xfrm>
            <a:off x="4985661" y="2079163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584622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hand holding a transparent sheet&#10;&#10;Description automatically generated">
            <a:extLst>
              <a:ext uri="{FF2B5EF4-FFF2-40B4-BE49-F238E27FC236}">
                <a16:creationId xmlns:a16="http://schemas.microsoft.com/office/drawing/2014/main" xmlns="" id="{B0261406-9A6D-D041-67F6-B3DA700870C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616" y="1199213"/>
            <a:ext cx="10553076" cy="56587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1EA7935-6DA0-316F-9BBF-C0BF737EBF77}"/>
              </a:ext>
            </a:extLst>
          </p:cNvPr>
          <p:cNvSpPr txBox="1"/>
          <p:nvPr/>
        </p:nvSpPr>
        <p:spPr>
          <a:xfrm>
            <a:off x="0" y="-3"/>
            <a:ext cx="2872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1B _Source Dat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17233B9-7028-4BCC-A211-04BBEC7242E1}"/>
              </a:ext>
            </a:extLst>
          </p:cNvPr>
          <p:cNvSpPr txBox="1"/>
          <p:nvPr/>
        </p:nvSpPr>
        <p:spPr>
          <a:xfrm rot="16200000">
            <a:off x="4799530" y="1524717"/>
            <a:ext cx="974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347081C3-E0CC-2690-D3AF-2580F8FF2ABF}"/>
              </a:ext>
            </a:extLst>
          </p:cNvPr>
          <p:cNvSpPr txBox="1"/>
          <p:nvPr/>
        </p:nvSpPr>
        <p:spPr>
          <a:xfrm rot="16200000">
            <a:off x="5180527" y="1535599"/>
            <a:ext cx="974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48CC007E-650D-5916-4B93-1C01617E1A57}"/>
              </a:ext>
            </a:extLst>
          </p:cNvPr>
          <p:cNvSpPr txBox="1"/>
          <p:nvPr/>
        </p:nvSpPr>
        <p:spPr>
          <a:xfrm rot="16200000">
            <a:off x="5605068" y="1426739"/>
            <a:ext cx="974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-1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AF88E0BD-7A8D-2128-7B85-376F57B1C683}"/>
              </a:ext>
            </a:extLst>
          </p:cNvPr>
          <p:cNvSpPr txBox="1"/>
          <p:nvPr/>
        </p:nvSpPr>
        <p:spPr>
          <a:xfrm rot="16200000">
            <a:off x="5696098" y="1191199"/>
            <a:ext cx="1663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-13 elg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B5A3B63D-5771-FFA1-015B-1B396CB35638}"/>
              </a:ext>
            </a:extLst>
          </p:cNvPr>
          <p:cNvSpPr txBox="1"/>
          <p:nvPr/>
        </p:nvSpPr>
        <p:spPr>
          <a:xfrm rot="16200000">
            <a:off x="6479870" y="1212968"/>
            <a:ext cx="1663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-164 elg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1515E23-7483-5C24-7D1F-76751DE82544}"/>
              </a:ext>
            </a:extLst>
          </p:cNvPr>
          <p:cNvSpPr txBox="1"/>
          <p:nvPr/>
        </p:nvSpPr>
        <p:spPr>
          <a:xfrm rot="16200000">
            <a:off x="6098873" y="1376250"/>
            <a:ext cx="1663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-164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xmlns="" id="{E672DDA1-35AF-7BC2-A7EA-2483FFF7E8CD}"/>
              </a:ext>
            </a:extLst>
          </p:cNvPr>
          <p:cNvCxnSpPr/>
          <p:nvPr/>
        </p:nvCxnSpPr>
        <p:spPr>
          <a:xfrm>
            <a:off x="5508173" y="2427514"/>
            <a:ext cx="324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xmlns="" id="{D903CEE6-ADC3-6E36-61E4-E8ABC7FC8664}"/>
              </a:ext>
            </a:extLst>
          </p:cNvPr>
          <p:cNvCxnSpPr/>
          <p:nvPr/>
        </p:nvCxnSpPr>
        <p:spPr>
          <a:xfrm>
            <a:off x="5921834" y="2416624"/>
            <a:ext cx="28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xmlns="" id="{1B11352D-D25A-4CFD-61B7-7DE24D1CDB80}"/>
              </a:ext>
            </a:extLst>
          </p:cNvPr>
          <p:cNvCxnSpPr/>
          <p:nvPr/>
        </p:nvCxnSpPr>
        <p:spPr>
          <a:xfrm>
            <a:off x="6313719" y="2416621"/>
            <a:ext cx="28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xmlns="" id="{F27E62D6-F450-B5DF-A595-0621B1DEB5E6}"/>
              </a:ext>
            </a:extLst>
          </p:cNvPr>
          <p:cNvCxnSpPr/>
          <p:nvPr/>
        </p:nvCxnSpPr>
        <p:spPr>
          <a:xfrm>
            <a:off x="6727376" y="2416620"/>
            <a:ext cx="28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xmlns="" id="{C56C7045-5079-2C9E-75F6-F61BA06BC4AF}"/>
              </a:ext>
            </a:extLst>
          </p:cNvPr>
          <p:cNvCxnSpPr/>
          <p:nvPr/>
        </p:nvCxnSpPr>
        <p:spPr>
          <a:xfrm>
            <a:off x="7151924" y="2416620"/>
            <a:ext cx="28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xmlns="" id="{27C33BD6-B763-F2BE-ADC1-AE279A0FE2CA}"/>
              </a:ext>
            </a:extLst>
          </p:cNvPr>
          <p:cNvCxnSpPr/>
          <p:nvPr/>
        </p:nvCxnSpPr>
        <p:spPr>
          <a:xfrm>
            <a:off x="5203372" y="2427513"/>
            <a:ext cx="25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17059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Widescreen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Armal</dc:creator>
  <cp:lastModifiedBy>Kate Armal</cp:lastModifiedBy>
  <cp:revision>1</cp:revision>
  <dcterms:created xsi:type="dcterms:W3CDTF">2023-08-01T06:21:53Z</dcterms:created>
  <dcterms:modified xsi:type="dcterms:W3CDTF">2023-08-01T06:22:20Z</dcterms:modified>
</cp:coreProperties>
</file>